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56"/>
    <p:restoredTop sz="95690"/>
  </p:normalViewPr>
  <p:slideViewPr>
    <p:cSldViewPr snapToGrid="0" snapToObjects="1">
      <p:cViewPr varScale="1">
        <p:scale>
          <a:sx n="116" d="100"/>
          <a:sy n="116" d="100"/>
        </p:scale>
        <p:origin x="1728" y="17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60F241-53A8-2A48-9F3E-C326E171246C}" type="datetimeFigureOut">
              <a:rPr lang="en-US" smtClean="0"/>
              <a:t>2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5C1359-21C4-4543-92A9-0CF0057A0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6201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5C1359-21C4-4543-92A9-0CF0057A0B0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4184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517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277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0263" y="274640"/>
            <a:ext cx="2227262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1" y="274640"/>
            <a:ext cx="6532563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79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649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517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1" y="1600202"/>
            <a:ext cx="4379913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27613" y="1600202"/>
            <a:ext cx="4379912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528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598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453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784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473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3160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1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153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53">
            <a:extLst>
              <a:ext uri="{FF2B5EF4-FFF2-40B4-BE49-F238E27FC236}">
                <a16:creationId xmlns:a16="http://schemas.microsoft.com/office/drawing/2014/main" id="{A1C86555-59F1-C04B-9976-5CDDDE7D30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9377" y="3846356"/>
            <a:ext cx="6234109" cy="1667482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F3336D79-E9DE-A146-9471-F007A3ADDFD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2235517"/>
            <a:ext cx="6442544" cy="1667482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DD512639-9B92-3D49-A42B-5614652627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120" y="817541"/>
            <a:ext cx="5943600" cy="11176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2044" y="633638"/>
            <a:ext cx="630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579878" y="633638"/>
            <a:ext cx="152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E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472234" y="633638"/>
            <a:ext cx="152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D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221922" y="633638"/>
            <a:ext cx="152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276052" y="633638"/>
            <a:ext cx="152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13469" y="1810105"/>
            <a:ext cx="3622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/>
              <a:t>24h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617361" y="1810105"/>
            <a:ext cx="3622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/>
              <a:t>72h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793430" y="1810105"/>
            <a:ext cx="3622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/>
              <a:t>72h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941904" y="1810105"/>
            <a:ext cx="3038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/>
              <a:t>7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167096" y="1810105"/>
            <a:ext cx="3038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/>
              <a:t>7d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19002" y="764913"/>
            <a:ext cx="1055737" cy="1114854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6208738" y="1767780"/>
            <a:ext cx="99578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800">
              <a:latin typeface="Arial"/>
              <a:cs typeface="Arial"/>
            </a:endParaRPr>
          </a:p>
          <a:p>
            <a:r>
              <a:rPr lang="en-US" sz="800">
                <a:latin typeface="Arial"/>
                <a:cs typeface="Arial"/>
              </a:rPr>
              <a:t>Donor BM:</a:t>
            </a:r>
          </a:p>
          <a:p>
            <a:r>
              <a:rPr lang="en-US" sz="800">
                <a:latin typeface="Arial"/>
                <a:cs typeface="Arial"/>
              </a:rPr>
              <a:t>75% WT(CD45.1)</a:t>
            </a:r>
          </a:p>
          <a:p>
            <a:r>
              <a:rPr lang="en-US" sz="800">
                <a:latin typeface="Arial"/>
                <a:cs typeface="Arial"/>
              </a:rPr>
              <a:t>25% WT(CD45.2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444576" y="1014722"/>
            <a:ext cx="638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/>
                <a:cs typeface="Arial"/>
              </a:rPr>
              <a:t>Total BM</a:t>
            </a:r>
          </a:p>
          <a:p>
            <a:r>
              <a:rPr lang="en-US" sz="900" dirty="0">
                <a:latin typeface="Arial"/>
                <a:cs typeface="Arial"/>
              </a:rPr>
              <a:t>Week 16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922542" y="109106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>
                <a:latin typeface="Arial" charset="0"/>
                <a:ea typeface="Arial" charset="0"/>
                <a:cs typeface="Arial" charset="0"/>
              </a:rPr>
              <a:t>24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672149" y="850047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>
                <a:latin typeface="Arial" charset="0"/>
                <a:ea typeface="Arial" charset="0"/>
                <a:cs typeface="Arial" charset="0"/>
              </a:rPr>
              <a:t>68</a:t>
            </a:r>
          </a:p>
        </p:txBody>
      </p:sp>
      <p:grpSp>
        <p:nvGrpSpPr>
          <p:cNvPr id="21" name="Group 20"/>
          <p:cNvGrpSpPr/>
          <p:nvPr/>
        </p:nvGrpSpPr>
        <p:grpSpPr>
          <a:xfrm>
            <a:off x="6312892" y="750174"/>
            <a:ext cx="2456106" cy="1609676"/>
            <a:chOff x="1433085" y="3598081"/>
            <a:chExt cx="2659928" cy="1609676"/>
          </a:xfrm>
          <a:effectLst/>
        </p:grpSpPr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598320" y="3598081"/>
              <a:ext cx="1143348" cy="1114854"/>
            </a:xfrm>
            <a:prstGeom prst="rect">
              <a:avLst/>
            </a:prstGeom>
          </p:spPr>
        </p:pic>
        <p:sp>
          <p:nvSpPr>
            <p:cNvPr id="23" name="TextBox 22"/>
            <p:cNvSpPr txBox="1"/>
            <p:nvPr/>
          </p:nvSpPr>
          <p:spPr>
            <a:xfrm>
              <a:off x="1433085" y="4578758"/>
              <a:ext cx="5784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/>
                  <a:cs typeface="Arial"/>
                </a:rPr>
                <a:t>CD45.2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766339" y="4622982"/>
              <a:ext cx="1326674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800">
                <a:latin typeface="Arial"/>
                <a:cs typeface="Arial"/>
              </a:endParaRPr>
            </a:p>
            <a:p>
              <a:r>
                <a:rPr lang="en-US" sz="800">
                  <a:latin typeface="Arial"/>
                  <a:cs typeface="Arial"/>
                </a:rPr>
                <a:t>Donor BM:</a:t>
              </a:r>
            </a:p>
            <a:p>
              <a:r>
                <a:rPr lang="en-US" sz="800">
                  <a:latin typeface="Arial"/>
                  <a:cs typeface="Arial"/>
                </a:rPr>
                <a:t>75% WT(CD45.1)</a:t>
              </a:r>
            </a:p>
            <a:p>
              <a:r>
                <a:rPr lang="en-US" sz="800">
                  <a:latin typeface="Arial"/>
                  <a:cs typeface="Arial"/>
                </a:rPr>
                <a:t>25% CD74-/- (CD45.2)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387010" y="3951300"/>
              <a:ext cx="3235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>
                  <a:latin typeface="Arial" charset="0"/>
                  <a:ea typeface="Arial" charset="0"/>
                  <a:cs typeface="Arial" charset="0"/>
                </a:rPr>
                <a:t>70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154331" y="3735856"/>
              <a:ext cx="3235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>
                  <a:latin typeface="Arial" charset="0"/>
                  <a:ea typeface="Arial" charset="0"/>
                  <a:cs typeface="Arial" charset="0"/>
                </a:rPr>
                <a:t>21</a:t>
              </a:r>
            </a:p>
          </p:txBody>
        </p:sp>
      </p:grpSp>
      <p:sp>
        <p:nvSpPr>
          <p:cNvPr id="28" name="TextBox 27"/>
          <p:cNvSpPr txBox="1"/>
          <p:nvPr/>
        </p:nvSpPr>
        <p:spPr>
          <a:xfrm rot="16200000">
            <a:off x="5889459" y="1400316"/>
            <a:ext cx="5341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CD45.1</a:t>
            </a:r>
          </a:p>
        </p:txBody>
      </p:sp>
      <p:cxnSp>
        <p:nvCxnSpPr>
          <p:cNvPr id="29" name="Straight Arrow Connector 28"/>
          <p:cNvCxnSpPr/>
          <p:nvPr/>
        </p:nvCxnSpPr>
        <p:spPr>
          <a:xfrm rot="16200000">
            <a:off x="6040164" y="1178054"/>
            <a:ext cx="221353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6026816" y="633638"/>
            <a:ext cx="152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F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FECA19E-432C-C740-9CD0-7BDA74F5B223}"/>
              </a:ext>
            </a:extLst>
          </p:cNvPr>
          <p:cNvSpPr txBox="1"/>
          <p:nvPr/>
        </p:nvSpPr>
        <p:spPr>
          <a:xfrm>
            <a:off x="49914" y="2063193"/>
            <a:ext cx="33058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Donors BM ratio:  7: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785049B-FDAC-A146-BFAA-EDA7A79C5F5B}"/>
              </a:ext>
            </a:extLst>
          </p:cNvPr>
          <p:cNvSpPr txBox="1"/>
          <p:nvPr/>
        </p:nvSpPr>
        <p:spPr>
          <a:xfrm>
            <a:off x="2223465" y="3863604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K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944358A-C3E5-8B45-BCAA-B44A0F91B4E8}"/>
              </a:ext>
            </a:extLst>
          </p:cNvPr>
          <p:cNvSpPr txBox="1"/>
          <p:nvPr/>
        </p:nvSpPr>
        <p:spPr>
          <a:xfrm>
            <a:off x="4372889" y="386360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L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F26EF64-7884-6241-BE0C-97A1BBE25B56}"/>
              </a:ext>
            </a:extLst>
          </p:cNvPr>
          <p:cNvSpPr txBox="1"/>
          <p:nvPr/>
        </p:nvSpPr>
        <p:spPr>
          <a:xfrm>
            <a:off x="94694" y="2254915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8A01BAD-E42F-E74F-B10E-32534796165A}"/>
              </a:ext>
            </a:extLst>
          </p:cNvPr>
          <p:cNvSpPr txBox="1"/>
          <p:nvPr/>
        </p:nvSpPr>
        <p:spPr>
          <a:xfrm>
            <a:off x="2223634" y="225491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H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057EC4A-435B-A94A-ABE4-7D79408EF626}"/>
              </a:ext>
            </a:extLst>
          </p:cNvPr>
          <p:cNvSpPr txBox="1"/>
          <p:nvPr/>
        </p:nvSpPr>
        <p:spPr>
          <a:xfrm flipH="1">
            <a:off x="4407968" y="2254915"/>
            <a:ext cx="324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I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812186F-5EA2-D84D-975D-92160842D55C}"/>
              </a:ext>
            </a:extLst>
          </p:cNvPr>
          <p:cNvSpPr txBox="1"/>
          <p:nvPr/>
        </p:nvSpPr>
        <p:spPr>
          <a:xfrm flipH="1">
            <a:off x="106027" y="3863604"/>
            <a:ext cx="324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J</a:t>
            </a: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95A89740-4928-CC43-8740-736C7FE2978C}"/>
              </a:ext>
            </a:extLst>
          </p:cNvPr>
          <p:cNvCxnSpPr>
            <a:cxnSpLocks/>
          </p:cNvCxnSpPr>
          <p:nvPr/>
        </p:nvCxnSpPr>
        <p:spPr>
          <a:xfrm>
            <a:off x="6784991" y="1832728"/>
            <a:ext cx="221353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0F044C44-C514-0045-94A1-5FD3B3DC812C}"/>
              </a:ext>
            </a:extLst>
          </p:cNvPr>
          <p:cNvSpPr/>
          <p:nvPr/>
        </p:nvSpPr>
        <p:spPr>
          <a:xfrm>
            <a:off x="49914" y="105468"/>
            <a:ext cx="907252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  <a:tabLst>
                <a:tab pos="114300" algn="l"/>
              </a:tabLst>
            </a:pPr>
            <a:r>
              <a:rPr lang="en-US" sz="1100" b="1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4 Fig</a:t>
            </a:r>
            <a:endParaRPr lang="en-US" sz="1100" dirty="0">
              <a:effectLst/>
              <a:latin typeface="Arial" panose="020B060402020202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49704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328</TotalTime>
  <Words>66</Words>
  <Application>Microsoft Macintosh PowerPoint</Application>
  <PresentationFormat>On-screen Show (4:3)</PresentationFormat>
  <Paragraphs>3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rly</dc:creator>
  <cp:lastModifiedBy>Microsoft Office User</cp:lastModifiedBy>
  <cp:revision>208</cp:revision>
  <cp:lastPrinted>2019-12-19T11:23:40Z</cp:lastPrinted>
  <dcterms:created xsi:type="dcterms:W3CDTF">2019-06-24T07:55:27Z</dcterms:created>
  <dcterms:modified xsi:type="dcterms:W3CDTF">2021-02-12T15:16:17Z</dcterms:modified>
</cp:coreProperties>
</file>